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8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666" y="-25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87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22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655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862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526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226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500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95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723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809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033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9BA390-8EAF-484A-B204-B74717EAA81D}" type="datetimeFigureOut">
              <a:rPr lang="en-US" smtClean="0"/>
              <a:t>4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7195FD-DA82-4ACA-A112-648A94F7D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422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5B7EA581-8C14-0C10-9B43-2C9E01C55A57}"/>
              </a:ext>
            </a:extLst>
          </p:cNvPr>
          <p:cNvSpPr txBox="1"/>
          <p:nvPr/>
        </p:nvSpPr>
        <p:spPr>
          <a:xfrm>
            <a:off x="218515" y="942975"/>
            <a:ext cx="6064624" cy="43179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Information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en-US" sz="1100" b="1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algn="l">
              <a:lnSpc>
                <a:spcPct val="150000"/>
              </a:lnSpc>
              <a:spcAft>
                <a:spcPts val="1200"/>
              </a:spcAft>
              <a:buNone/>
            </a:pPr>
            <a:r>
              <a:rPr lang="en-GB" sz="24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terations in Circulating Progenitor Cell Composition in Rheumatoid Arthritis</a:t>
            </a:r>
            <a:r>
              <a:rPr lang="en-GB" sz="12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  </a:t>
            </a:r>
            <a:endParaRPr lang="de-CH" sz="11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ts val="1300"/>
              </a:lnSpc>
              <a:spcAft>
                <a:spcPts val="1800"/>
              </a:spcAft>
              <a:buNone/>
            </a:pP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va Camarillo-Retamosa 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Jan Devan 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Camino Calvo-Cebrián 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Alexandra Khmelevskaya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Kristina Bürki 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Raphael Micheroli 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b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drian Ciurea 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Stefan Dudli 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GB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Caroline Ospelt </a:t>
            </a:r>
            <a:r>
              <a:rPr lang="en-GB" sz="12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,</a:t>
            </a:r>
            <a:endParaRPr lang="de-CH" sz="12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180975" indent="-180975" algn="l">
              <a:lnSpc>
                <a:spcPts val="1000"/>
              </a:lnSpc>
              <a:buAutoNum type="arabicPlain"/>
            </a:pPr>
            <a:r>
              <a:rPr lang="en-GB" sz="105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nter of Experimental Rheumatology, Department of Rheumatology, University Hospital Zurich, University of Zurich, Zurich, Switzerland; </a:t>
            </a:r>
          </a:p>
          <a:p>
            <a:pPr marL="1884680" indent="-228600" algn="l">
              <a:lnSpc>
                <a:spcPts val="1000"/>
              </a:lnSpc>
              <a:buAutoNum type="arabicPlain"/>
            </a:pPr>
            <a:endParaRPr lang="en-GB" sz="1050" baseline="3000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180975" indent="-180975" algn="l">
              <a:lnSpc>
                <a:spcPts val="1000"/>
              </a:lnSpc>
              <a:buAutoNum type="arabicPlain"/>
            </a:pPr>
            <a:r>
              <a:rPr lang="en-GB" sz="105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epartment of Physical Medicine and Rheumatology, Balgrist University Hospital, Balgrist Campus, University of Zurich, Zurich, Switzerland</a:t>
            </a:r>
            <a:endParaRPr lang="de-CH" sz="12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endParaRPr lang="en-US" sz="1200" b="1"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endParaRPr lang="de-CH" sz="110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17967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FEB5EE00-0A2B-6800-0502-A3486B20D898}"/>
              </a:ext>
            </a:extLst>
          </p:cNvPr>
          <p:cNvSpPr txBox="1"/>
          <p:nvPr/>
        </p:nvSpPr>
        <p:spPr>
          <a:xfrm>
            <a:off x="0" y="4672429"/>
            <a:ext cx="6778256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Table </a:t>
            </a:r>
            <a:r>
              <a:rPr lang="en-US" sz="10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1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Cellular Populations frequency and significance. The table contains the cell surface markers expressed for each cell population received from the </a:t>
            </a:r>
            <a:r>
              <a:rPr lang="en-US" sz="10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FlowSOM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clustering analysis. The mean and SD for the frequency (percentage) of each cell population within the cohorts, HC (n = 9) and RA (n = 12) are listed with the p-value, the statistical significance and the corrected p-value (Bonferroni)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C1654A3-033B-3EF8-4680-0B94A0E021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958" y="1255829"/>
            <a:ext cx="6661298" cy="3237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98674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0DC79F87-2068-A494-33AF-503A6E48477B}"/>
              </a:ext>
            </a:extLst>
          </p:cNvPr>
          <p:cNvSpPr txBox="1"/>
          <p:nvPr/>
        </p:nvSpPr>
        <p:spPr>
          <a:xfrm>
            <a:off x="406268" y="4953000"/>
            <a:ext cx="604546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</a:t>
            </a:r>
            <a:r>
              <a:rPr lang="en-US" sz="10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1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. Relation of age with subpopulations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. Pearson correlation analysis between age and  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(a)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Pop 4, 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(b)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Pop 12  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(c)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Pop 18 and 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(d)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naive T cells. 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D5D6B0D8-3D61-8C38-6E82-CEC82EECBA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268" y="257175"/>
            <a:ext cx="5048250" cy="4695825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CF202CD7-0A84-CEEE-D246-043060EB0DC4}"/>
              </a:ext>
            </a:extLst>
          </p:cNvPr>
          <p:cNvSpPr txBox="1"/>
          <p:nvPr/>
        </p:nvSpPr>
        <p:spPr>
          <a:xfrm>
            <a:off x="403062" y="26455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41CF7C31-8024-A6CB-9207-DD8E2A04BC6A}"/>
              </a:ext>
            </a:extLst>
          </p:cNvPr>
          <p:cNvSpPr txBox="1"/>
          <p:nvPr/>
        </p:nvSpPr>
        <p:spPr>
          <a:xfrm>
            <a:off x="2909555" y="26455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D2E3F5D6-4772-9E01-795F-108226C496CC}"/>
              </a:ext>
            </a:extLst>
          </p:cNvPr>
          <p:cNvSpPr txBox="1"/>
          <p:nvPr/>
        </p:nvSpPr>
        <p:spPr>
          <a:xfrm>
            <a:off x="403062" y="257553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AD9106F8-02AE-BC25-CBDD-0A62695E0486}"/>
              </a:ext>
            </a:extLst>
          </p:cNvPr>
          <p:cNvSpPr txBox="1"/>
          <p:nvPr/>
        </p:nvSpPr>
        <p:spPr>
          <a:xfrm>
            <a:off x="2909555" y="257553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7542533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DA1A9787-DB2B-6107-5332-18D76E45D3CC}"/>
              </a:ext>
            </a:extLst>
          </p:cNvPr>
          <p:cNvSpPr txBox="1"/>
          <p:nvPr/>
        </p:nvSpPr>
        <p:spPr>
          <a:xfrm>
            <a:off x="322411" y="8591944"/>
            <a:ext cx="604546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</a:t>
            </a:r>
            <a:r>
              <a:rPr lang="en-US" sz="10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2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. Manual gating strategy and dot plots of each patient. (a)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Manual sequential flow cytometry gating strategy. Bivariate dot </a:t>
            </a:r>
            <a:r>
              <a:rPr lang="en-US" sz="10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lost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shown </a:t>
            </a:r>
            <a:r>
              <a:rPr lang="en-US" sz="10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D235a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and </a:t>
            </a:r>
            <a:r>
              <a:rPr lang="en-US" sz="10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D45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expression profiles for (b) HC samples and (c) RA samples.  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0C069399-AC19-8DE4-E85C-173CEAB60C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232" y="372454"/>
            <a:ext cx="5745103" cy="79270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3800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5</Words>
  <Application>Microsoft Office PowerPoint</Application>
  <PresentationFormat>A4 Paper (210x297 mm)</PresentationFormat>
  <Paragraphs>1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Palatino Linotype</vt:lpstr>
      <vt:lpstr>Office</vt:lpstr>
      <vt:lpstr>PowerPoint Presentation</vt:lpstr>
      <vt:lpstr>PowerPoint Presentation</vt:lpstr>
      <vt:lpstr>PowerPoint Presentation</vt:lpstr>
      <vt:lpstr>PowerPoint Presentation</vt:lpstr>
    </vt:vector>
  </TitlesOfParts>
  <Company>US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spelt Caroline</dc:creator>
  <cp:lastModifiedBy>MDPI</cp:lastModifiedBy>
  <cp:revision>17</cp:revision>
  <dcterms:created xsi:type="dcterms:W3CDTF">2025-03-03T14:47:55Z</dcterms:created>
  <dcterms:modified xsi:type="dcterms:W3CDTF">2026-04-19T14:53:09Z</dcterms:modified>
</cp:coreProperties>
</file>